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C9F34-C5A5-438F-9F21-DCA9BBA8E6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16856-7B95-429B-9B73-0F60F5D765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C664A-4FB1-45D5-A392-5688B9049A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B3466-453A-4264-852B-A33375C1CC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EE428-CA0A-45FF-80DB-1C72D65194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6A692-5812-4C0D-9DCF-4A25882C46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8477B-33CF-4E4E-82F3-2620DF26E0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DA87A-BC3C-4640-9976-05334EAADB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8C22D-1ED2-4154-AFE7-2D51595109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272F6-33E6-4EA7-916C-31CEBE8F30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30C4A-E0D1-4DE3-9294-329AEE2354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FAA3F-7018-4BBB-A28C-ADCD4B133D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BAF594-ECE8-4BD5-B3D3-8D3B13085FA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4"/>
          <p:cNvSpPr/>
          <p:nvPr/>
        </p:nvSpPr>
        <p:spPr>
          <a:xfrm>
            <a:off x="3147120" y="-92520"/>
            <a:ext cx="2849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Supplementary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15"/>
          <p:cNvSpPr/>
          <p:nvPr/>
        </p:nvSpPr>
        <p:spPr>
          <a:xfrm>
            <a:off x="0" y="40258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Gruppierung 1"/>
          <p:cNvGrpSpPr/>
          <p:nvPr/>
        </p:nvGrpSpPr>
        <p:grpSpPr>
          <a:xfrm>
            <a:off x="0" y="311040"/>
            <a:ext cx="5807160" cy="3743280"/>
            <a:chOff x="0" y="311040"/>
            <a:chExt cx="5807160" cy="3743280"/>
          </a:xfrm>
        </p:grpSpPr>
        <p:pic>
          <p:nvPicPr>
            <p:cNvPr id="44" name="Bild 4" descr=""/>
            <p:cNvPicPr/>
            <p:nvPr/>
          </p:nvPicPr>
          <p:blipFill>
            <a:blip r:embed="rId1"/>
            <a:stretch/>
          </p:blipFill>
          <p:spPr>
            <a:xfrm>
              <a:off x="0" y="311040"/>
              <a:ext cx="5064840" cy="3743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Gruppierung 5"/>
            <p:cNvGrpSpPr/>
            <p:nvPr/>
          </p:nvGrpSpPr>
          <p:grpSpPr>
            <a:xfrm>
              <a:off x="4885560" y="336960"/>
              <a:ext cx="921600" cy="360000"/>
              <a:chOff x="4885560" y="336960"/>
              <a:chExt cx="921600" cy="360000"/>
            </a:xfrm>
          </p:grpSpPr>
          <p:pic>
            <p:nvPicPr>
              <p:cNvPr id="46" name="Bild 6" descr=""/>
              <p:cNvPicPr/>
              <p:nvPr/>
            </p:nvPicPr>
            <p:blipFill>
              <a:blip r:embed="rId2"/>
              <a:stretch/>
            </p:blipFill>
            <p:spPr>
              <a:xfrm>
                <a:off x="4885560" y="336960"/>
                <a:ext cx="921600" cy="36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Rechteck 7"/>
              <p:cNvSpPr/>
              <p:nvPr/>
            </p:nvSpPr>
            <p:spPr>
              <a:xfrm>
                <a:off x="4908600" y="504360"/>
                <a:ext cx="172800" cy="33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8" name="Rechteck 1"/>
          <p:cNvSpPr/>
          <p:nvPr/>
        </p:nvSpPr>
        <p:spPr>
          <a:xfrm>
            <a:off x="0" y="4025880"/>
            <a:ext cx="5807160" cy="157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itochondrial respiration in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ermeabilized ventricular apex tissue specimens obtained during left ventricular assist device surgery after cold storage for 0, 3 and 8h in BIOPS or CUSTODIOL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reservation buffer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i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ochondrial respiration was analysed on a) Octanoyl-carnitine; 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ctanoyl-carnitine and the citrate cycle derived substrates glutamate and succinate; c) Uncoupled respiration after addition of the uncoupler fccp (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arbonyl cyanide-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[trifluoromethoxy]phenylhydrazone]);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d) Respiratory control ratio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ans ± SEM, 2-way ANOVA (n=7-9 BIOPS; n=5-8 CUSTODIOL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22T23:12:38Z</dcterms:created>
  <dc:creator>Daniel Scheiber</dc:creator>
  <dc:description/>
  <dc:language>en-US</dc:language>
  <cp:lastModifiedBy>Daniel Scheiber</cp:lastModifiedBy>
  <dcterms:modified xsi:type="dcterms:W3CDTF">2018-03-29T22:50:07Z</dcterms:modified>
  <cp:revision>8</cp:revision>
  <dc:subject/>
  <dc:title>PowerPoint-Präsentation</dc:title>
</cp:coreProperties>
</file>